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8" r:id="rId4"/>
    <p:sldId id="267" r:id="rId5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FE9D7A-7BB7-4B33-B644-019739D3A8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59DA54F-1B3D-4D61-9F1A-E8141F6E1A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F00D22-AFF2-42FD-B61D-87A8BEE83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713D1C-86EF-48C1-96F9-162CBBD76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4CEE7B-AF2F-4268-9932-736863BA4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042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804189-8B80-467E-A116-4D8827DD02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30262B-F689-4A26-BE47-C7B7822AB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A58628-7D80-4B4B-B328-AFBE5E701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69BE7F-6C7A-4E5F-A5CA-97E0F721F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49C385-F064-4857-86C0-D006E6180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248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D8A96FD-7409-4516-9A58-9925AC0090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566E2D-624E-49BC-BA2D-8204247A0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157DE5-66AA-48C8-8C5F-EDDDE0E75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3BD889-381A-44B1-8E1B-FA4D552A4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B17F47-EB8A-4A7B-8B6F-697B23E08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567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37014A-020B-4A4E-835B-319A72EE1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53E64F-4539-4303-892B-469D3397A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6792A9-ABED-4A05-8506-71AB3F0D1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2F9B39-A6E9-4F80-89ED-80DBEBDF9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6BAC11-7692-4110-97D1-F15B76339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987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3E7893-578D-4499-9E3A-025AA412D5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B38879-1A7F-4DC4-9ED7-8BD3D7F52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0C2A41-326D-438C-8982-DFBA12623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7484C4-B243-4079-8D3E-356858E6B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4821F4-C896-47EC-9C88-8C2B3A66E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401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9CDAA-D7E2-41B5-B49F-3D0E38220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33CC74-918C-4004-8FFD-B031FEB85E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135A3F-9989-4EC9-948F-A0A4437F7E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EB634C-A826-487E-A4B4-1843C63E5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7330683-C697-4967-8FBD-064F9E3CB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7FA126-9403-4E16-92D1-51635B3C8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8156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6BC1E-A303-47E1-9713-C6C448837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3AD3B1-9202-4CBB-B665-5E84B14DE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E122F54-C7B6-4E57-8AFB-3182172EF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338F84F-5D6B-4B92-95B8-78190B567D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55871D7-FF42-4E30-91AE-1331D5C7F1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089A046-9031-4A93-98AE-D7012E76D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AB32581-6571-48F4-AA86-F8C873F26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23FBF26-92A5-4BFC-A81A-62484A8BD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619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B0123B-ECEE-49ED-BCCC-E3154DA305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F49AC0F-2268-40DB-AD23-91DF207EE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D48DEEF-EC3B-42B6-B412-0F4B640D5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6F33491-93DC-4F89-94B5-5B9AB780A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824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E9D2335-2DCC-4D94-9C1B-EAB8F5F31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4842860-1238-4BF3-BFAC-5AFD3A0DF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5E03DB3-B7A7-4246-A378-9A8F6EC91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155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2A50DE-5544-48AB-A3E7-9F9317DC8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D39CBE-7523-4695-983C-269802577D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0F9D03-FE72-4BEF-925D-80410B2643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7D7AF4-7638-48BC-A101-2CD98A6F5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F45E925-FBD8-4E38-BD3B-5F0A5EC0C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2090A1-0B69-4F96-9F46-6D834F569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472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196B87-2AD3-4E1C-BA37-917A83714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FCDBE5-AD6E-48D9-AEDD-688323D461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7BCD23-5D99-4552-88B9-E6A5AA8C95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A9CDC1-B93D-4455-B478-2E8B90974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D45A78-0BD6-4AC4-A6DC-A63EBA48D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7A73A3-7146-4E56-B16A-88B2DBE7F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263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A538EA-E8B7-4025-A61A-0494FA8EF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05C9045-F503-48D1-BE0D-12A15F022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7E0643-D578-4BEF-B1C0-CA43D04011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23159-2BF9-403D-B077-1E0FB0501340}" type="datetimeFigureOut">
              <a:rPr kumimoji="1" lang="ja-JP" altLang="en-US" smtClean="0"/>
              <a:t>2023/5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67F7CB-BE00-4D45-BF76-BF4CF30DE7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AD9C81-1D80-4470-A242-319303CED0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643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89CFB0AB-9352-4933-ADD6-3CDE069A08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4157498"/>
              </p:ext>
            </p:extLst>
          </p:nvPr>
        </p:nvGraphicFramePr>
        <p:xfrm>
          <a:off x="1384662" y="1057229"/>
          <a:ext cx="9791338" cy="455553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692489">
                  <a:extLst>
                    <a:ext uri="{9D8B030D-6E8A-4147-A177-3AD203B41FA5}">
                      <a16:colId xmlns:a16="http://schemas.microsoft.com/office/drawing/2014/main" val="1432191378"/>
                    </a:ext>
                  </a:extLst>
                </a:gridCol>
                <a:gridCol w="2515562">
                  <a:extLst>
                    <a:ext uri="{9D8B030D-6E8A-4147-A177-3AD203B41FA5}">
                      <a16:colId xmlns:a16="http://schemas.microsoft.com/office/drawing/2014/main" val="1274041952"/>
                    </a:ext>
                  </a:extLst>
                </a:gridCol>
                <a:gridCol w="2583287">
                  <a:extLst>
                    <a:ext uri="{9D8B030D-6E8A-4147-A177-3AD203B41FA5}">
                      <a16:colId xmlns:a16="http://schemas.microsoft.com/office/drawing/2014/main" val="2839333166"/>
                    </a:ext>
                  </a:extLst>
                </a:gridCol>
              </a:tblGrid>
              <a:tr h="2530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continuation group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discontinuation group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92511159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246645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age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(± 6.8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 (± 8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5647078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US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 (± 3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9 (± 3.7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91504650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initial PSA at diagnosis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6.6 (± 3507.3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0.9 (± 1554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825187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time-to-CRPC (month)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3 (± 31.6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7 (± 41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49102048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SA before ENZ administration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 (± 214.9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 (± 148.6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16483927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eason score 8 or more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335986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</a:t>
                      </a:r>
                      <a:r>
                        <a:rPr lang="en-US" sz="14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ite (other than bone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3928365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ymph nodes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81708947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ung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2409172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iver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7205905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-line therapy after CRPC diagnosi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1860219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Enzalutamide </a:t>
                      </a:r>
                      <a:endParaRPr lang="ja-JP" alt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9004492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AT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7359153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biraterone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17629286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Docetaxel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28286703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Ra223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71647489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C65B83D-3A97-49C6-8BA0-88AB7475748D}"/>
              </a:ext>
            </a:extLst>
          </p:cNvPr>
          <p:cNvSpPr txBox="1"/>
          <p:nvPr/>
        </p:nvSpPr>
        <p:spPr>
          <a:xfrm>
            <a:off x="278205" y="410898"/>
            <a:ext cx="109012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ackground characteristics and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inical factors for patients in the enzalutamide </a:t>
            </a:r>
            <a:b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tinuation and discontinuation groups</a:t>
            </a:r>
            <a:endParaRPr lang="ja-JP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78205" y="5612759"/>
            <a:ext cx="1128630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NZ continuation group: ENZ was effective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ntinued during the observation period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NZ discontinuation group: Patients became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fractory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treatment was discontinued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uring the observation period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re were no significant differences between groups.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each clinical factor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b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AT, alternative nonsteroidal Antiandrogen therapy; </a:t>
            </a:r>
            <a:r>
              <a:rPr lang="en-US" altLang="ja-JP" sz="1400" kern="100" dirty="0">
                <a:latin typeface="Arial" panose="020B0604020202020204" pitchFamily="34" charset="0"/>
                <a:cs typeface="Arial" panose="020B0604020202020204" pitchFamily="34" charset="0"/>
              </a:rPr>
              <a:t>BMI, body mass index;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RPC,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stration-resistant prostate cancer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ENZ, enzalutamide; PSA, prostate-specific antigen; SD, standard deviation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2527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5DFD0D36-76E3-448A-98FB-E5B84D8D60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4072430"/>
              </p:ext>
            </p:extLst>
          </p:nvPr>
        </p:nvGraphicFramePr>
        <p:xfrm>
          <a:off x="5289633" y="127583"/>
          <a:ext cx="6257932" cy="650137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498801">
                  <a:extLst>
                    <a:ext uri="{9D8B030D-6E8A-4147-A177-3AD203B41FA5}">
                      <a16:colId xmlns:a16="http://schemas.microsoft.com/office/drawing/2014/main" val="2410052859"/>
                    </a:ext>
                  </a:extLst>
                </a:gridCol>
                <a:gridCol w="1759131">
                  <a:extLst>
                    <a:ext uri="{9D8B030D-6E8A-4147-A177-3AD203B41FA5}">
                      <a16:colId xmlns:a16="http://schemas.microsoft.com/office/drawing/2014/main" val="1713889206"/>
                    </a:ext>
                  </a:extLst>
                </a:gridCol>
              </a:tblGrid>
              <a:tr h="13062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993115061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years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6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2388611660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1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4250630495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itial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 (&gt;1300 ng/mL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6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3187823656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eason score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7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5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399746133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-to-CRPC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 months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7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194083504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 metastases (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1529395105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 metastases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3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1789401809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 metastases (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2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3951430464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 of denosumab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4057999207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ation therapy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9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3482745009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 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3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52297565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after docetaxel (yes or no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1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630976488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 after abiraterone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 or no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4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2581854866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 before ENZ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 ng/mL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2509893333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 at 3 months after ENZ</a:t>
                      </a:r>
                      <a:r>
                        <a:rPr lang="en-US" sz="12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ja-JP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ng/mL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2129025000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I before ENZ (&gt;1.3%)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2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4167482055"/>
                  </a:ext>
                </a:extLst>
              </a:tr>
              <a:tr h="36425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kumimoji="1" lang="en-GB" altLang="ja-JP" sz="1200" b="1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best BSI change </a:t>
                      </a:r>
                      <a:r>
                        <a:rPr lang="en-US" sz="120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ncrease or decrease)</a:t>
                      </a:r>
                      <a:endParaRPr lang="ja-JP" sz="120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1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50392" marR="50392" marT="0" marB="0"/>
                </a:tc>
                <a:extLst>
                  <a:ext uri="{0D108BD9-81ED-4DB2-BD59-A6C34878D82A}">
                    <a16:rowId xmlns:a16="http://schemas.microsoft.com/office/drawing/2014/main" val="2410129003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438902E-AB5D-4E7C-A64A-5B2CB6E6AEE5}"/>
              </a:ext>
            </a:extLst>
          </p:cNvPr>
          <p:cNvSpPr txBox="1"/>
          <p:nvPr/>
        </p:nvSpPr>
        <p:spPr>
          <a:xfrm>
            <a:off x="0" y="415599"/>
            <a:ext cx="5181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Univariate analysis of clinical factors for patients in the enzalutamide continuation and discontinuation groups</a:t>
            </a:r>
            <a:endParaRPr lang="ja-JP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26274" y="2362608"/>
            <a:ext cx="4929051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 clinical factors significant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ly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correlated with ENZ continuation/discontinuation: a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crease in PSA (&lt;32 ng/ mL) 3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onth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fter ENZ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(</a:t>
            </a:r>
            <a:r>
              <a:rPr lang="ja-JP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9)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a decrease in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SI as </a:t>
            </a:r>
            <a:r>
              <a:rPr lang="en-GB" altLang="ja-JP" sz="14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est BSI change while on ENZ treatment at the end of the observation period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31).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1400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AT, alternative nonsteroidal antiandrogen therapy; </a:t>
            </a:r>
            <a:r>
              <a:rPr lang="en-US" altLang="ja-JP" sz="1400" kern="100" dirty="0">
                <a:latin typeface="Arial" panose="020B0604020202020204" pitchFamily="34" charset="0"/>
                <a:cs typeface="Arial" panose="020B0604020202020204" pitchFamily="34" charset="0"/>
              </a:rPr>
              <a:t>BMI, body mass index;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SI, bone scan index; CRPC, </a:t>
            </a:r>
            <a:r>
              <a:rPr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stration-resistant prostate cancer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ENZ, enzalutamide; PSA, prostate-specific antigen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24014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76F658B-5B45-707E-63CB-B17CE9665D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4896811"/>
              </p:ext>
            </p:extLst>
          </p:nvPr>
        </p:nvGraphicFramePr>
        <p:xfrm>
          <a:off x="900466" y="1444307"/>
          <a:ext cx="9140179" cy="295757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053273">
                  <a:extLst>
                    <a:ext uri="{9D8B030D-6E8A-4147-A177-3AD203B41FA5}">
                      <a16:colId xmlns:a16="http://schemas.microsoft.com/office/drawing/2014/main" val="1432191378"/>
                    </a:ext>
                  </a:extLst>
                </a:gridCol>
                <a:gridCol w="2024109">
                  <a:extLst>
                    <a:ext uri="{9D8B030D-6E8A-4147-A177-3AD203B41FA5}">
                      <a16:colId xmlns:a16="http://schemas.microsoft.com/office/drawing/2014/main" val="1274041952"/>
                    </a:ext>
                  </a:extLst>
                </a:gridCol>
                <a:gridCol w="1873189">
                  <a:extLst>
                    <a:ext uri="{9D8B030D-6E8A-4147-A177-3AD203B41FA5}">
                      <a16:colId xmlns:a16="http://schemas.microsoft.com/office/drawing/2014/main" val="2839333166"/>
                    </a:ext>
                  </a:extLst>
                </a:gridCol>
                <a:gridCol w="1189608">
                  <a:extLst>
                    <a:ext uri="{9D8B030D-6E8A-4147-A177-3AD203B41FA5}">
                      <a16:colId xmlns:a16="http://schemas.microsoft.com/office/drawing/2014/main" val="1255959681"/>
                    </a:ext>
                  </a:extLst>
                </a:gridCol>
              </a:tblGrid>
              <a:tr h="2530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visceral metastase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out visceral metastase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i="1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400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92511159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patients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4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246645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age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 (± 8.1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(± 7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9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5647078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US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 (± 3.3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9 (± 3.6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7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91504650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initial PSA at diagnosis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 (± 821.2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 (± 3018.2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29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825187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time-to-CRPC (month)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± 29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± 38.3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5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49102048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SA before ENZ administration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(± 133.7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 (± 194.1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7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16483927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eason score 8 or more </a:t>
                      </a: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1 (73%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59 (79%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7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335986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</a:t>
                      </a:r>
                      <a:r>
                        <a:rPr lang="en-US" sz="14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ite (other than bone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3928365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ung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3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-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2409172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iver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3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-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7205905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2A32DDD-924A-9FEE-4E5D-CFF6E8B6D030}"/>
              </a:ext>
            </a:extLst>
          </p:cNvPr>
          <p:cNvSpPr txBox="1"/>
          <p:nvPr/>
        </p:nvSpPr>
        <p:spPr>
          <a:xfrm>
            <a:off x="158532" y="751381"/>
            <a:ext cx="114013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.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ackground characteristics and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inical factors for patients with and without visceral </a:t>
            </a:r>
            <a:b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etastases.</a:t>
            </a:r>
            <a:endParaRPr lang="ja-JP" altLang="ja-JP" sz="18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F918041-C83F-EA5A-307A-CEE916D2BF4C}"/>
              </a:ext>
            </a:extLst>
          </p:cNvPr>
          <p:cNvSpPr txBox="1"/>
          <p:nvPr/>
        </p:nvSpPr>
        <p:spPr>
          <a:xfrm>
            <a:off x="1935332" y="494486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070348D-05A5-301D-8D4C-F42CFA06CF64}"/>
              </a:ext>
            </a:extLst>
          </p:cNvPr>
          <p:cNvSpPr txBox="1"/>
          <p:nvPr/>
        </p:nvSpPr>
        <p:spPr>
          <a:xfrm>
            <a:off x="344707" y="5213748"/>
            <a:ext cx="1128630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f the 90 patients, 15 had visceral metastasis (one patient had both lung and liver metastases). There were no significant differences in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ackground characteristics or clinical factors between the two groups.</a:t>
            </a:r>
            <a:b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sher’s exact test was used for categorical variables, and the t-test was used for normally distributed continuous variables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7861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A6DF69C-BB88-F617-904E-F40B562CDF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7006079"/>
              </p:ext>
            </p:extLst>
          </p:nvPr>
        </p:nvGraphicFramePr>
        <p:xfrm>
          <a:off x="914399" y="1590318"/>
          <a:ext cx="8797772" cy="321065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910150">
                  <a:extLst>
                    <a:ext uri="{9D8B030D-6E8A-4147-A177-3AD203B41FA5}">
                      <a16:colId xmlns:a16="http://schemas.microsoft.com/office/drawing/2014/main" val="1432191378"/>
                    </a:ext>
                  </a:extLst>
                </a:gridCol>
                <a:gridCol w="2020388">
                  <a:extLst>
                    <a:ext uri="{9D8B030D-6E8A-4147-A177-3AD203B41FA5}">
                      <a16:colId xmlns:a16="http://schemas.microsoft.com/office/drawing/2014/main" val="1274041952"/>
                    </a:ext>
                  </a:extLst>
                </a:gridCol>
                <a:gridCol w="1680754">
                  <a:extLst>
                    <a:ext uri="{9D8B030D-6E8A-4147-A177-3AD203B41FA5}">
                      <a16:colId xmlns:a16="http://schemas.microsoft.com/office/drawing/2014/main" val="2839333166"/>
                    </a:ext>
                  </a:extLst>
                </a:gridCol>
                <a:gridCol w="1186480">
                  <a:extLst>
                    <a:ext uri="{9D8B030D-6E8A-4147-A177-3AD203B41FA5}">
                      <a16:colId xmlns:a16="http://schemas.microsoft.com/office/drawing/2014/main" val="596289316"/>
                    </a:ext>
                  </a:extLst>
                </a:gridCol>
              </a:tblGrid>
              <a:tr h="25308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untendo </a:t>
                      </a: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in hospital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affiliated hospitals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i="1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400" baseline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92511159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ja-JP" sz="1400" b="1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400" b="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246645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age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 (± 7.8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(± 7.3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8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5647078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US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0 (± 3.1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1 (± 4.0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33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91504650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initial PSA at diagnosis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.5 (± 3181.5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 (± 2337.6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6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8251874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time-to-CRPC (month)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± 34.3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5 (± 39.4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3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49102048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SA before ENZ administration 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altLang="ja-JP" sz="1400" b="0" kern="100" baseline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r>
                        <a:rPr lang="en-US" altLang="ja-JP" sz="1400" b="0" kern="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ja-JP" sz="1400" b="0" kern="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 (± 159.7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 (± 209.8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99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16483927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eason score 8 or more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36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.00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3359861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</a:t>
                      </a:r>
                      <a:r>
                        <a:rPr lang="en-US" sz="1400" kern="1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ite (other than bone)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4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3928365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ymph nodes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48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81708947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ung</a:t>
                      </a:r>
                      <a:endParaRPr lang="ja-JP" sz="1400" b="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9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14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92409172"/>
                  </a:ext>
                </a:extLst>
              </a:tr>
              <a:tr h="25308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400" b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iver</a:t>
                      </a:r>
                      <a:endParaRPr lang="ja-JP" sz="1400" b="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1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2</a:t>
                      </a:r>
                      <a:endParaRPr lang="ja-JP" sz="14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ja-JP" sz="14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7205905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3DBAA99-9919-0C65-3799-1EF7E1C82F48}"/>
              </a:ext>
            </a:extLst>
          </p:cNvPr>
          <p:cNvSpPr txBox="1"/>
          <p:nvPr/>
        </p:nvSpPr>
        <p:spPr>
          <a:xfrm>
            <a:off x="344707" y="666988"/>
            <a:ext cx="1080295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. 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ackground characteristics and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inical factors for patients at the Juntendo University main hospital and </a:t>
            </a:r>
            <a:b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Juntendo affiliated hospitals</a:t>
            </a:r>
            <a:endParaRPr lang="ja-JP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6E7FEC1-1F25-4A83-CE0E-C5D19A958A1B}"/>
              </a:ext>
            </a:extLst>
          </p:cNvPr>
          <p:cNvSpPr txBox="1"/>
          <p:nvPr/>
        </p:nvSpPr>
        <p:spPr>
          <a:xfrm>
            <a:off x="344707" y="5213748"/>
            <a:ext cx="112863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 main hospital of Juntendo University Hospital, in addition to BSI and PSA tests, CTC analyses were also performed. For the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Juntendo affiliated hospital group, CTC analyses were not performed (Juntendo </a:t>
            </a:r>
            <a:r>
              <a:rPr lang="en-GB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Urayasu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Hospital, Juntendo Nerima Hospital, Juntendo Shizuoka Hospital, and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Juntendo Tokyo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oto Geriatric Hospital)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re were no significant differences in </a:t>
            </a:r>
            <a: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ackground characteristics or clinical factors between the two groups.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sher’s exact test was used for categorical variables, and the t-test was used for normally distributed continuous variables. </a:t>
            </a:r>
            <a:br>
              <a:rPr lang="en-GB" altLang="ja-JP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7989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5</TotalTime>
  <Words>929</Words>
  <Application>Microsoft Office PowerPoint</Application>
  <PresentationFormat>ワイド画面</PresentationFormat>
  <Paragraphs>18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政義 永田</dc:creator>
  <cp:lastModifiedBy>永田 政義</cp:lastModifiedBy>
  <cp:revision>116</cp:revision>
  <cp:lastPrinted>2021-01-19T00:19:30Z</cp:lastPrinted>
  <dcterms:created xsi:type="dcterms:W3CDTF">2020-11-22T13:38:21Z</dcterms:created>
  <dcterms:modified xsi:type="dcterms:W3CDTF">2023-05-16T12:03:06Z</dcterms:modified>
</cp:coreProperties>
</file>